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5" d="100"/>
          <a:sy n="65" d="100"/>
        </p:scale>
        <p:origin x="3318" y="2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5804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81116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85853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23790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1020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62888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88538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61327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91021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88538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05039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32ECC40-4C37-4AAB-B992-398C5862C12D}" type="datetimeFigureOut">
              <a:rPr kumimoji="1" lang="ja-JP" altLang="en-US" smtClean="0"/>
              <a:t>2025/10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67262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8ED0ABC2-2F35-D02A-7B3C-B5B1E69E7943}"/>
              </a:ext>
            </a:extLst>
          </p:cNvPr>
          <p:cNvSpPr txBox="1"/>
          <p:nvPr/>
        </p:nvSpPr>
        <p:spPr>
          <a:xfrm>
            <a:off x="549000" y="6642333"/>
            <a:ext cx="5760000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7.</a:t>
            </a:r>
            <a:endParaRPr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sartan (LOS) affects extracellular signal-regulated kinase (ERK) and Akt signaling in angiotensin II (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gII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type 1 receptor (AGTR1)-overexpressing tumors. (A) Western blot analysis of tumors harvested from mice transplanted with AGTR1-overexpressing (AGTR1) T24 cells, with or without LOS treatment. Phosphorylation dynamics and total expression levels of ERK and Akt were evaluated. β-actin was used as a loading control. Representative results from three mice in each group are shown. (B) β-actin–normalized ERK levels (left) and p‑ERK/ERK ratios (right) in tumors from mice with or without LOS treatment. (C) β-actin–normalized Akt levels (left) and p‑Akt/Akt ratios (right) in tumors from mice with or without LOS treatment. Data are presented as mean ± standard error of the mean (SEM) (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3). *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 and individual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values determined by Welch’s t-test are indicated.</a:t>
            </a:r>
            <a:endParaRPr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9D6256E8-1790-ECC8-F4BC-07104DBFAB2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3970" y="1509341"/>
            <a:ext cx="5410059" cy="41041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470786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186</Words>
  <Application>Microsoft Office PowerPoint</Application>
  <PresentationFormat>A4 210 x 297 mm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神沼　修</dc:creator>
  <cp:lastModifiedBy>神沼　修</cp:lastModifiedBy>
  <cp:revision>6</cp:revision>
  <dcterms:created xsi:type="dcterms:W3CDTF">2025-07-04T02:55:30Z</dcterms:created>
  <dcterms:modified xsi:type="dcterms:W3CDTF">2025-10-22T03:51:31Z</dcterms:modified>
</cp:coreProperties>
</file>